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4412"/>
    <p:restoredTop sz="94564"/>
  </p:normalViewPr>
  <p:slideViewPr>
    <p:cSldViewPr snapToGrid="0" snapToObjects="1">
      <p:cViewPr varScale="1">
        <p:scale>
          <a:sx n="110" d="100"/>
          <a:sy n="110" d="100"/>
        </p:scale>
        <p:origin x="1242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C1C47FCC-A7DE-C54A-AF25-CF3134A986F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xmlns="" id="{AE7335D1-9E70-0F40-8D7A-5846EAE0A26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6EE7B809-7739-2041-ABA9-A6904F399A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AC7CE-8A88-364C-B00A-8E138C27736F}" type="datetimeFigureOut">
              <a:rPr lang="fr-FR" smtClean="0"/>
              <a:t>10/01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B7757A54-BC13-414D-8EE1-7BF7D104ED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AFCF5D12-1CCC-BD4C-8210-4124CE6CC8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D58DF-7C6B-0440-9EEF-F1F87F28B54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552045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41008995-ACAF-0946-AD65-4CE39C0BC75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xmlns="" id="{0488A24C-E8CB-B040-AA5D-806F652E390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A24A3198-AF85-6A48-BD97-04AF11696C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AC7CE-8A88-364C-B00A-8E138C27736F}" type="datetimeFigureOut">
              <a:rPr lang="fr-FR" smtClean="0"/>
              <a:t>10/01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C9384A95-3E38-634E-B52B-B6724BCFE9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56465BA2-750C-1741-B28D-3AF19FE8A7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D58DF-7C6B-0440-9EEF-F1F87F28B54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651598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xmlns="" id="{1B74A11C-5EAD-384B-A797-CF6C3FC46DA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xmlns="" id="{4BCC255D-C3D0-4B48-9811-29E6A0E1AB0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3F087BCE-BC84-8A4B-A6DD-15DA3A7EAD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AC7CE-8A88-364C-B00A-8E138C27736F}" type="datetimeFigureOut">
              <a:rPr lang="fr-FR" smtClean="0"/>
              <a:t>10/01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00315A85-6106-0C47-BB9B-CB1C66D27C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F7171A8F-7A7B-E844-9679-7577E733CC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D58DF-7C6B-0440-9EEF-F1F87F28B54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811842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CC211D9F-F5A1-7042-8E40-A09644020C0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xmlns="" id="{4480A747-1346-9A49-8CBF-135E486DD69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0431BFC2-859F-1548-8F03-2E015A16D3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AC7CE-8A88-364C-B00A-8E138C27736F}" type="datetimeFigureOut">
              <a:rPr lang="fr-FR" smtClean="0"/>
              <a:t>10/01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9BA5BB7D-B8DC-604E-A60B-64B232C6BF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D689A912-A922-4A41-B698-98CAB56ADA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D58DF-7C6B-0440-9EEF-F1F87F28B54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936004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54158ABA-C837-7645-81F3-E22661BB465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xmlns="" id="{1A94E275-C56D-114A-973C-4B146AE16CB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371FC319-B4C7-C540-9A64-006870F329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AC7CE-8A88-364C-B00A-8E138C27736F}" type="datetimeFigureOut">
              <a:rPr lang="fr-FR" smtClean="0"/>
              <a:t>10/01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2F7601ED-9DB0-F74A-B8A5-4DDD44A655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4AFFA59A-9C30-4A4B-AB32-E5A44E5AD1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D58DF-7C6B-0440-9EEF-F1F87F28B54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184920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36ED1D9D-1F13-7948-9876-A23D68E43D4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xmlns="" id="{1F42A0A5-9A38-5845-8A12-BD65F659128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xmlns="" id="{2014C03D-1629-774A-8077-08A08A9EF02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xmlns="" id="{8AB58E07-2FEA-2A40-ADFD-E9B12B4714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AC7CE-8A88-364C-B00A-8E138C27736F}" type="datetimeFigureOut">
              <a:rPr lang="fr-FR" smtClean="0"/>
              <a:t>10/01/2022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xmlns="" id="{472D9183-631D-7746-83B7-6063090080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xmlns="" id="{08906376-8AEB-AF46-A0F7-89B6A08E6B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D58DF-7C6B-0440-9EEF-F1F87F28B54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780805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FE2A39C2-238F-5F4A-89CE-D2FC66BC00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xmlns="" id="{9FD09BB6-60CB-A94E-96C5-91A64B38E7F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xmlns="" id="{B8C6C03C-8CD1-6745-A502-D457C47E0EF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xmlns="" id="{6AA6C744-41E5-6146-BEBD-28F01027415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xmlns="" id="{84BD8341-81E2-154C-9A40-E9F5E2055AD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xmlns="" id="{02EADBF0-605E-2242-8437-77C2770D03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AC7CE-8A88-364C-B00A-8E138C27736F}" type="datetimeFigureOut">
              <a:rPr lang="fr-FR" smtClean="0"/>
              <a:t>10/01/2022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xmlns="" id="{897B657F-7620-314C-94A0-0644E7FA06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xmlns="" id="{5476E10A-C084-5A44-8CE6-8BA554AD48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D58DF-7C6B-0440-9EEF-F1F87F28B54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922637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FD9BC954-A6D5-4D4D-A357-3BC169A3EF8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xmlns="" id="{C5A5F159-5A9B-0742-9BA5-346A8EFF2B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AC7CE-8A88-364C-B00A-8E138C27736F}" type="datetimeFigureOut">
              <a:rPr lang="fr-FR" smtClean="0"/>
              <a:t>10/01/2022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xmlns="" id="{EA834B68-E640-AA43-8D8A-8AA7BDA00D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xmlns="" id="{6EB35191-87D9-C947-AAA2-7F38B9D766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D58DF-7C6B-0440-9EEF-F1F87F28B54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057162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xmlns="" id="{52860CFD-2CAE-514D-A399-5060F78FE4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AC7CE-8A88-364C-B00A-8E138C27736F}" type="datetimeFigureOut">
              <a:rPr lang="fr-FR" smtClean="0"/>
              <a:t>10/01/2022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xmlns="" id="{B51CB7B5-4807-4045-9E29-469425F39F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xmlns="" id="{445DFEF4-31E9-EF4C-8A54-2A7E38C14A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D58DF-7C6B-0440-9EEF-F1F87F28B54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176846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548C810C-9DFA-104C-8724-BC1B2505567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xmlns="" id="{5961EEE8-83FB-4940-BC3D-85AEC4914A7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xmlns="" id="{5DB4D2E8-AF5C-2541-9208-2C51333DD85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xmlns="" id="{7E9E150B-D3DF-9F4E-B6FB-9A8D2BD9CF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AC7CE-8A88-364C-B00A-8E138C27736F}" type="datetimeFigureOut">
              <a:rPr lang="fr-FR" smtClean="0"/>
              <a:t>10/01/2022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xmlns="" id="{67CB1BD0-B1C2-844B-882F-CA2A1C5443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xmlns="" id="{C522ED37-4F7C-8748-B605-C66B9D088B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D58DF-7C6B-0440-9EEF-F1F87F28B54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524497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258696F9-A462-7B44-AB22-FA5F96AEB6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xmlns="" id="{FD8D893F-F9F7-D64D-9627-711FD95FAC9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xmlns="" id="{431A3F29-4BD5-8C4E-AD6B-C3D31951472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xmlns="" id="{EEB28BA0-189F-CE4B-A0AB-327D086278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AC7CE-8A88-364C-B00A-8E138C27736F}" type="datetimeFigureOut">
              <a:rPr lang="fr-FR" smtClean="0"/>
              <a:t>10/01/2022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xmlns="" id="{E3FCC168-F240-2343-9B8F-E39D54BFB2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xmlns="" id="{89868A88-B99D-2742-A011-FF14528AEF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D58DF-7C6B-0440-9EEF-F1F87F28B54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356485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xmlns="" id="{9BEB9B36-CA2C-8B46-91F3-5CCF05EF52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xmlns="" id="{F77A482A-3857-8046-8B6A-FCB53250581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AF433CD6-F44C-094C-A03F-9BE1DF0733F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BAC7CE-8A88-364C-B00A-8E138C27736F}" type="datetimeFigureOut">
              <a:rPr lang="fr-FR" smtClean="0"/>
              <a:t>10/01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311BA33E-3BD6-BC40-BAE0-7AB6FA3AA6E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9F73945D-303E-4B43-8388-09D2C93541D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2D58DF-7C6B-0440-9EEF-F1F87F28B54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471611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>
            <a:extLst>
              <a:ext uri="{FF2B5EF4-FFF2-40B4-BE49-F238E27FC236}">
                <a16:creationId xmlns:a16="http://schemas.microsoft.com/office/drawing/2014/main" xmlns="" id="{DFF63B23-2ABF-6442-8D25-EAFAFB43187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50690" y="1533319"/>
            <a:ext cx="4140200" cy="3340100"/>
          </a:xfrm>
          <a:prstGeom prst="rect">
            <a:avLst/>
          </a:prstGeom>
        </p:spPr>
      </p:pic>
      <p:sp>
        <p:nvSpPr>
          <p:cNvPr id="5" name="ZoneTexte 4">
            <a:extLst>
              <a:ext uri="{FF2B5EF4-FFF2-40B4-BE49-F238E27FC236}">
                <a16:creationId xmlns:a16="http://schemas.microsoft.com/office/drawing/2014/main" xmlns="" id="{85ACD430-B180-524A-89F7-19A4A96A0146}"/>
              </a:ext>
            </a:extLst>
          </p:cNvPr>
          <p:cNvSpPr txBox="1"/>
          <p:nvPr/>
        </p:nvSpPr>
        <p:spPr>
          <a:xfrm>
            <a:off x="1003947" y="5374384"/>
            <a:ext cx="10033686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/>
              <a:t>Additional file 2. Changes of microvascular reactivity according to baseline peripheral tissue perfusion in septic shock patients. </a:t>
            </a:r>
            <a:r>
              <a:rPr lang="en-US" sz="1400" dirty="0"/>
              <a:t>Vitamin C administration improved microvascular perfusion in patients with (CRT&gt; 2 sec) and without (CRT&gt; 2 sec) impaired tissue perfusion. Data are expressed as median and IQRs. AUC for area under the curve and CRT for capillary refill time.</a:t>
            </a:r>
            <a:endParaRPr lang="fr-FR" sz="1400" dirty="0"/>
          </a:p>
        </p:txBody>
      </p:sp>
    </p:spTree>
    <p:extLst>
      <p:ext uri="{BB962C8B-B14F-4D97-AF65-F5344CB8AC3E}">
        <p14:creationId xmlns:p14="http://schemas.microsoft.com/office/powerpoint/2010/main" val="110733691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8</TotalTime>
  <Words>67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icrosoft Office User</dc:creator>
  <cp:lastModifiedBy>Femina P.</cp:lastModifiedBy>
  <cp:revision>16</cp:revision>
  <dcterms:created xsi:type="dcterms:W3CDTF">2021-09-29T14:29:35Z</dcterms:created>
  <dcterms:modified xsi:type="dcterms:W3CDTF">2022-01-10T12:07:48Z</dcterms:modified>
</cp:coreProperties>
</file>